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9" r:id="rId4"/>
    <p:sldId id="265" r:id="rId5"/>
    <p:sldId id="268" r:id="rId6"/>
    <p:sldId id="257" r:id="rId7"/>
    <p:sldId id="262" r:id="rId8"/>
    <p:sldId id="264" r:id="rId9"/>
    <p:sldId id="261" r:id="rId10"/>
    <p:sldId id="267" r:id="rId11"/>
    <p:sldId id="263" r:id="rId12"/>
    <p:sldId id="266" r:id="rId13"/>
    <p:sldId id="260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customXml" Target="../customXml/item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7" Type="http://schemas.openxmlformats.org/officeDocument/2006/relationships/tableStyles" Target="tableStyles.xml"/><Relationship Id="rId12" Type="http://schemas.openxmlformats.org/officeDocument/2006/relationships/slide" Target="slides/slide10.xml"/><Relationship Id="rId2" Type="http://schemas.openxmlformats.org/officeDocument/2006/relationships/theme" Target="theme/theme1.xml"/><Relationship Id="rId16" Type="http://schemas.openxmlformats.org/officeDocument/2006/relationships/viewProps" Target="viewProps.xml"/><Relationship Id="rId20" Type="http://schemas.openxmlformats.org/officeDocument/2006/relationships/customXml" Target="../customXml/item3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1" Type="http://schemas.openxmlformats.org/officeDocument/2006/relationships/slideMaster" Target="slideMasters/slideMaster1.xml"/><Relationship Id="rId5" Type="http://schemas.openxmlformats.org/officeDocument/2006/relationships/slide" Target="slides/slide3.xml"/><Relationship Id="rId15" Type="http://schemas.openxmlformats.org/officeDocument/2006/relationships/presProps" Target="presProps.xml"/><Relationship Id="rId10" Type="http://schemas.openxmlformats.org/officeDocument/2006/relationships/slide" Target="slides/slide8.xml"/><Relationship Id="rId19" Type="http://schemas.openxmlformats.org/officeDocument/2006/relationships/customXml" Target="../customXml/item2.xml"/><Relationship Id="rId9" Type="http://schemas.openxmlformats.org/officeDocument/2006/relationships/slide" Target="slides/slide7.xml"/><Relationship Id="rId4" Type="http://schemas.openxmlformats.org/officeDocument/2006/relationships/slide" Target="slides/slide2.xml"/><Relationship Id="rId14" Type="http://schemas.openxmlformats.org/officeDocument/2006/relationships/slide" Target="slides/slide1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17.xml"/><Relationship Id="rId8" Type="http://schemas.openxmlformats.org/officeDocument/2006/relationships/image" Target="../media/image62.png"/><Relationship Id="rId7" Type="http://schemas.openxmlformats.org/officeDocument/2006/relationships/tags" Target="../tags/tag16.xml"/><Relationship Id="rId6" Type="http://schemas.openxmlformats.org/officeDocument/2006/relationships/image" Target="../media/image61.png"/><Relationship Id="rId5" Type="http://schemas.openxmlformats.org/officeDocument/2006/relationships/image" Target="../media/image60.png"/><Relationship Id="rId4" Type="http://schemas.openxmlformats.org/officeDocument/2006/relationships/tags" Target="../tags/tag15.xml"/><Relationship Id="rId3" Type="http://schemas.openxmlformats.org/officeDocument/2006/relationships/tags" Target="../tags/tag14.xml"/><Relationship Id="rId21" Type="http://schemas.openxmlformats.org/officeDocument/2006/relationships/slideLayout" Target="../slideLayouts/slideLayout2.xml"/><Relationship Id="rId20" Type="http://schemas.openxmlformats.org/officeDocument/2006/relationships/tags" Target="../tags/tag24.xml"/><Relationship Id="rId2" Type="http://schemas.openxmlformats.org/officeDocument/2006/relationships/image" Target="../media/image59.png"/><Relationship Id="rId19" Type="http://schemas.openxmlformats.org/officeDocument/2006/relationships/tags" Target="../tags/tag23.xml"/><Relationship Id="rId18" Type="http://schemas.openxmlformats.org/officeDocument/2006/relationships/tags" Target="../tags/tag22.xml"/><Relationship Id="rId17" Type="http://schemas.openxmlformats.org/officeDocument/2006/relationships/image" Target="../media/image66.png"/><Relationship Id="rId16" Type="http://schemas.openxmlformats.org/officeDocument/2006/relationships/tags" Target="../tags/tag21.xml"/><Relationship Id="rId15" Type="http://schemas.openxmlformats.org/officeDocument/2006/relationships/tags" Target="../tags/tag20.xml"/><Relationship Id="rId14" Type="http://schemas.openxmlformats.org/officeDocument/2006/relationships/image" Target="../media/image65.png"/><Relationship Id="rId13" Type="http://schemas.openxmlformats.org/officeDocument/2006/relationships/tags" Target="../tags/tag19.xml"/><Relationship Id="rId12" Type="http://schemas.openxmlformats.org/officeDocument/2006/relationships/image" Target="../media/image64.png"/><Relationship Id="rId11" Type="http://schemas.openxmlformats.org/officeDocument/2006/relationships/image" Target="../media/image63.png"/><Relationship Id="rId10" Type="http://schemas.openxmlformats.org/officeDocument/2006/relationships/tags" Target="../tags/tag18.xml"/><Relationship Id="rId1" Type="http://schemas.openxmlformats.org/officeDocument/2006/relationships/tags" Target="../tags/tag13.xml"/></Relationships>
</file>

<file path=ppt/slides/_rels/slide1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4" Type="http://schemas.openxmlformats.org/officeDocument/2006/relationships/image" Target="../media/image70.png"/><Relationship Id="rId3" Type="http://schemas.openxmlformats.org/officeDocument/2006/relationships/image" Target="../media/image69.png"/><Relationship Id="rId2" Type="http://schemas.openxmlformats.org/officeDocument/2006/relationships/image" Target="../media/image68.png"/><Relationship Id="rId1" Type="http://schemas.openxmlformats.org/officeDocument/2006/relationships/image" Target="../media/image67.png"/></Relationships>
</file>

<file path=ppt/slides/_rels/slide1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78.png"/><Relationship Id="rId5" Type="http://schemas.openxmlformats.org/officeDocument/2006/relationships/image" Target="../media/image77.png"/><Relationship Id="rId4" Type="http://schemas.openxmlformats.org/officeDocument/2006/relationships/image" Target="../media/image76.png"/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image" Target="../media/image73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14.png"/><Relationship Id="rId7" Type="http://schemas.openxmlformats.org/officeDocument/2006/relationships/image" Target="../media/image13.png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8.png"/><Relationship Id="rId8" Type="http://schemas.openxmlformats.org/officeDocument/2006/relationships/tags" Target="../tags/tag5.xml"/><Relationship Id="rId7" Type="http://schemas.openxmlformats.org/officeDocument/2006/relationships/image" Target="../media/image17.png"/><Relationship Id="rId6" Type="http://schemas.openxmlformats.org/officeDocument/2006/relationships/tags" Target="../tags/tag4.xml"/><Relationship Id="rId5" Type="http://schemas.openxmlformats.org/officeDocument/2006/relationships/tags" Target="../tags/tag3.xml"/><Relationship Id="rId4" Type="http://schemas.openxmlformats.org/officeDocument/2006/relationships/image" Target="../media/image16.png"/><Relationship Id="rId3" Type="http://schemas.openxmlformats.org/officeDocument/2006/relationships/tags" Target="../tags/tag2.xml"/><Relationship Id="rId2" Type="http://schemas.openxmlformats.org/officeDocument/2006/relationships/image" Target="../media/image15.png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openxmlformats.org/officeDocument/2006/relationships/tags" Target="../tags/tag7.xml"/><Relationship Id="rId10" Type="http://schemas.openxmlformats.org/officeDocument/2006/relationships/tags" Target="../tags/tag6.xml"/><Relationship Id="rId1" Type="http://schemas.openxmlformats.org/officeDocument/2006/relationships/tags" Target="../tags/tag1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26.png"/><Relationship Id="rId7" Type="http://schemas.openxmlformats.org/officeDocument/2006/relationships/image" Target="../media/image25.png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34.png"/><Relationship Id="rId7" Type="http://schemas.openxmlformats.org/officeDocument/2006/relationships/image" Target="../media/image33.png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42.png"/><Relationship Id="rId7" Type="http://schemas.openxmlformats.org/officeDocument/2006/relationships/image" Target="../media/image41.png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50.png"/><Relationship Id="rId7" Type="http://schemas.openxmlformats.org/officeDocument/2006/relationships/image" Target="../media/image49.png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image" Target="../media/image43.png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54.png"/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image" Target="../media/image51.png"/></Relationships>
</file>

<file path=ppt/slides/_rels/slide9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58.png"/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image" Target="../media/image5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59155" y="960755"/>
            <a:ext cx="2538730" cy="13766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2075" y="443230"/>
            <a:ext cx="767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2-A</a:t>
            </a:r>
            <a:endParaRPr lang="en-US" altLang="zh-CN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2245" y="1027430"/>
            <a:ext cx="1748155" cy="162433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4465" y="2794000"/>
            <a:ext cx="1765935" cy="184785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18015" y="755015"/>
            <a:ext cx="1414145" cy="198247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67850" y="2910840"/>
            <a:ext cx="1464310" cy="194564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3935" y="2651760"/>
            <a:ext cx="2281555" cy="193357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90500" y="1480185"/>
            <a:ext cx="881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92075" y="3387725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3550920" y="1464945"/>
            <a:ext cx="8121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3390265" y="3533775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5252720" y="343535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Fig2-B</a:t>
            </a:r>
            <a:endParaRPr lang="en-US" altLang="zh-CN"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696325" y="343535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Fig2-C</a:t>
            </a:r>
            <a:endParaRPr lang="en-US" altLang="zh-CN">
              <a:sym typeface="+mn-ea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516120" y="1464945"/>
            <a:ext cx="881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4419600" y="3533775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7174230" y="1480185"/>
            <a:ext cx="8121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11200765" y="1480185"/>
            <a:ext cx="8121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8542655" y="3836670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7187565" y="3599180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11119485" y="3836670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8494395" y="1480185"/>
            <a:ext cx="881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612265" y="1786255"/>
            <a:ext cx="1350645" cy="154813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3"/>
            </p:custDataLst>
          </p:nvPr>
        </p:nvSpPr>
        <p:spPr>
          <a:xfrm>
            <a:off x="697865" y="2376170"/>
            <a:ext cx="838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c-Myc</a:t>
            </a:r>
            <a:endParaRPr lang="en-US" altLang="zh-CN"/>
          </a:p>
        </p:txBody>
      </p:sp>
      <p:pic>
        <p:nvPicPr>
          <p:cNvPr id="7" name="图片 6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5023485" y="1652905"/>
            <a:ext cx="1303655" cy="153924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9240" y="152400"/>
            <a:ext cx="1496695" cy="146621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539240" y="5012055"/>
            <a:ext cx="1311910" cy="1373505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9"/>
            </p:custDataLst>
          </p:nvPr>
        </p:nvSpPr>
        <p:spPr>
          <a:xfrm>
            <a:off x="612140" y="5464175"/>
            <a:ext cx="8483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5071745" y="4937760"/>
            <a:ext cx="1099820" cy="14478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23180" y="59055"/>
            <a:ext cx="1203960" cy="149733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5071745" y="3334385"/>
            <a:ext cx="1103630" cy="1509395"/>
          </a:xfrm>
          <a:prstGeom prst="rect">
            <a:avLst/>
          </a:prstGeom>
        </p:spPr>
      </p:pic>
      <p:sp>
        <p:nvSpPr>
          <p:cNvPr id="3" name="文本框 2"/>
          <p:cNvSpPr txBox="1"/>
          <p:nvPr>
            <p:custDataLst>
              <p:tags r:id="rId15"/>
            </p:custDataLst>
          </p:nvPr>
        </p:nvSpPr>
        <p:spPr>
          <a:xfrm>
            <a:off x="774065" y="3929380"/>
            <a:ext cx="686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TKT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1539240" y="3502025"/>
            <a:ext cx="1342390" cy="134239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54025" y="395605"/>
            <a:ext cx="10064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P: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612140" y="763905"/>
            <a:ext cx="7219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B:Ub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017010" y="468630"/>
            <a:ext cx="10064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P:c-Myc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232910" y="836930"/>
            <a:ext cx="7219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B:Ub</a:t>
            </a:r>
            <a:endParaRPr lang="zh-CN" altLang="en-US"/>
          </a:p>
        </p:txBody>
      </p:sp>
      <p:sp>
        <p:nvSpPr>
          <p:cNvPr id="19" name="文本框 18"/>
          <p:cNvSpPr txBox="1"/>
          <p:nvPr>
            <p:custDataLst>
              <p:tags r:id="rId18"/>
            </p:custDataLst>
          </p:nvPr>
        </p:nvSpPr>
        <p:spPr>
          <a:xfrm>
            <a:off x="4185285" y="2376170"/>
            <a:ext cx="838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c-Myc</a:t>
            </a:r>
            <a:endParaRPr lang="en-US" altLang="zh-CN"/>
          </a:p>
        </p:txBody>
      </p:sp>
      <p:sp>
        <p:nvSpPr>
          <p:cNvPr id="20" name="文本框 19"/>
          <p:cNvSpPr txBox="1"/>
          <p:nvPr>
            <p:custDataLst>
              <p:tags r:id="rId19"/>
            </p:custDataLst>
          </p:nvPr>
        </p:nvSpPr>
        <p:spPr>
          <a:xfrm>
            <a:off x="4268470" y="3929380"/>
            <a:ext cx="686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TKT</a:t>
            </a:r>
            <a:endParaRPr lang="zh-CN" altLang="en-US"/>
          </a:p>
        </p:txBody>
      </p:sp>
      <p:sp>
        <p:nvSpPr>
          <p:cNvPr id="21" name="文本框 20"/>
          <p:cNvSpPr txBox="1"/>
          <p:nvPr>
            <p:custDataLst>
              <p:tags r:id="rId20"/>
            </p:custDataLst>
          </p:nvPr>
        </p:nvSpPr>
        <p:spPr>
          <a:xfrm>
            <a:off x="4185285" y="5514975"/>
            <a:ext cx="8483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3129280" y="2376170"/>
            <a:ext cx="8299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6405245" y="2376170"/>
            <a:ext cx="1039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3020695" y="3989070"/>
            <a:ext cx="9385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6341745" y="4051935"/>
            <a:ext cx="8445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3048000" y="5601970"/>
            <a:ext cx="77660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6327140" y="5514975"/>
            <a:ext cx="817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270510" y="59055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I 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3683000" y="6350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J </a:t>
            </a:r>
            <a:endParaRPr lang="en-US" altLang="zh-CN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271780" y="174625"/>
            <a:ext cx="8699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5-A</a:t>
            </a:r>
            <a:endParaRPr lang="en-US" altLang="zh-CN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12290" y="546735"/>
            <a:ext cx="1926590" cy="143637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2290" y="2337435"/>
            <a:ext cx="1927225" cy="122618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680085" y="913765"/>
            <a:ext cx="12338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-Myc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709295" y="2766695"/>
            <a:ext cx="904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2290" y="3984625"/>
            <a:ext cx="1981200" cy="122555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09295" y="441325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38365" y="2213610"/>
            <a:ext cx="1557655" cy="147510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38365" y="3919220"/>
            <a:ext cx="1521460" cy="147447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38365" y="472440"/>
            <a:ext cx="1452245" cy="151066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468870" y="4546600"/>
            <a:ext cx="976630" cy="294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6127750" y="454660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6276975" y="2656205"/>
            <a:ext cx="904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6276975" y="825500"/>
            <a:ext cx="847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-Myc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3887470" y="999490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8804910" y="825500"/>
            <a:ext cx="10902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3834765" y="2766695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8915400" y="2656205"/>
            <a:ext cx="7867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3887470" y="4472305"/>
            <a:ext cx="887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8926195" y="4546600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6202045" y="178435"/>
            <a:ext cx="8699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5-D</a:t>
            </a:r>
            <a:endParaRPr lang="en-US" altLang="zh-CN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97915" y="2265045"/>
            <a:ext cx="1229995" cy="140589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26695" y="126365"/>
            <a:ext cx="7962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6-E   </a:t>
            </a:r>
            <a:endParaRPr lang="en-US" altLang="zh-CN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3310" y="3784600"/>
            <a:ext cx="1244600" cy="140398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9500" y="1058545"/>
            <a:ext cx="1248410" cy="10928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19405" y="1197610"/>
            <a:ext cx="981075" cy="25336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2546350" y="1197610"/>
            <a:ext cx="10604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2490" y="2247265"/>
            <a:ext cx="1069975" cy="140589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2490" y="862330"/>
            <a:ext cx="1070610" cy="121475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81700" y="3761105"/>
            <a:ext cx="1041400" cy="142748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5151755" y="423164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139065" y="410527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5065395" y="1197610"/>
            <a:ext cx="981075" cy="25336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427355" y="2681605"/>
            <a:ext cx="6559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TKT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 flipH="1">
            <a:off x="5065395" y="2681605"/>
            <a:ext cx="728980" cy="3892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TKT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7171055" y="1197610"/>
            <a:ext cx="10604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2546350" y="2681605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7160260" y="2681605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2422525" y="4165600"/>
            <a:ext cx="887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7171055" y="4231640"/>
            <a:ext cx="887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4998085" y="253365"/>
            <a:ext cx="7962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6-F   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82700" y="2445385"/>
            <a:ext cx="1125220" cy="115125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700" y="2933065"/>
            <a:ext cx="1261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N-cadherin</a:t>
            </a:r>
            <a:endParaRPr lang="zh-CN" altLang="en-US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9520" y="5422900"/>
            <a:ext cx="1176655" cy="10674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95275" y="5761355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9520" y="3921760"/>
            <a:ext cx="1169035" cy="117602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0" y="4340860"/>
            <a:ext cx="1362710" cy="39179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Vimentin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8740" y="690245"/>
            <a:ext cx="1067435" cy="118872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2700" y="1143635"/>
            <a:ext cx="13976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-cadherin</a:t>
            </a:r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77740" y="502285"/>
            <a:ext cx="1057910" cy="137668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92345" y="2035175"/>
            <a:ext cx="999490" cy="148526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79950" y="5357495"/>
            <a:ext cx="1155700" cy="130556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85665" y="3645535"/>
            <a:ext cx="1149985" cy="140335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2478405" y="5761355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5944235" y="5826125"/>
            <a:ext cx="1014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2478405" y="4364355"/>
            <a:ext cx="8604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4kD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5944235" y="436435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4kDa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2478405" y="2844165"/>
            <a:ext cx="9277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30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5835650" y="2844165"/>
            <a:ext cx="8940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30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2532380" y="1143635"/>
            <a:ext cx="9264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25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5835650" y="1142365"/>
            <a:ext cx="8940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25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3575050" y="1059815"/>
            <a:ext cx="13976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-cadherin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491230" y="2844165"/>
            <a:ext cx="1261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N-cadherin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3534410" y="4340860"/>
            <a:ext cx="1362710" cy="39179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Vimentin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763645" y="5895340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295275" y="205740"/>
            <a:ext cx="767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2-J</a:t>
            </a:r>
            <a:endParaRPr lang="en-US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" name="图片 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560830" y="1203325"/>
            <a:ext cx="1814830" cy="173863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5622925" y="1222375"/>
            <a:ext cx="1786255" cy="1719580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5"/>
            </p:custDataLst>
          </p:nvPr>
        </p:nvSpPr>
        <p:spPr>
          <a:xfrm>
            <a:off x="782320" y="3993515"/>
            <a:ext cx="56261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TKT</a:t>
            </a:r>
            <a:endParaRPr lang="zh-CN" altLang="en-US"/>
          </a:p>
          <a:p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1560830" y="3256915"/>
            <a:ext cx="1881505" cy="171005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5617210" y="3138170"/>
            <a:ext cx="1852930" cy="1681480"/>
          </a:xfrm>
          <a:prstGeom prst="rect">
            <a:avLst/>
          </a:prstGeom>
        </p:spPr>
      </p:pic>
      <p:sp>
        <p:nvSpPr>
          <p:cNvPr id="4" name="文本框 3"/>
          <p:cNvSpPr txBox="1"/>
          <p:nvPr>
            <p:custDataLst>
              <p:tags r:id="rId10"/>
            </p:custDataLst>
          </p:nvPr>
        </p:nvSpPr>
        <p:spPr>
          <a:xfrm>
            <a:off x="782320" y="1793875"/>
            <a:ext cx="7112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RAF1</a:t>
            </a:r>
            <a:endParaRPr lang="en-US" altLang="zh-CN"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11"/>
            </p:custDataLst>
          </p:nvPr>
        </p:nvSpPr>
        <p:spPr>
          <a:xfrm>
            <a:off x="3562350" y="1701165"/>
            <a:ext cx="1180465" cy="4610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	73kDa</a:t>
            </a:r>
            <a:endParaRPr lang="zh-CN" altLang="en-US"/>
          </a:p>
        </p:txBody>
      </p:sp>
      <p:sp>
        <p:nvSpPr>
          <p:cNvPr id="3" name="文本框 2"/>
          <p:cNvSpPr txBox="1"/>
          <p:nvPr>
            <p:custDataLst>
              <p:tags r:id="rId12"/>
            </p:custDataLst>
          </p:nvPr>
        </p:nvSpPr>
        <p:spPr>
          <a:xfrm>
            <a:off x="6771005" y="3927475"/>
            <a:ext cx="1775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	73kDa</a:t>
            </a:r>
            <a:endParaRPr lang="zh-CN" altLang="en-US"/>
          </a:p>
        </p:txBody>
      </p:sp>
      <p:sp>
        <p:nvSpPr>
          <p:cNvPr id="5" name="文本框 4"/>
          <p:cNvSpPr txBox="1"/>
          <p:nvPr>
            <p:custDataLst>
              <p:tags r:id="rId13"/>
            </p:custDataLst>
          </p:nvPr>
        </p:nvSpPr>
        <p:spPr>
          <a:xfrm>
            <a:off x="4742815" y="3993515"/>
            <a:ext cx="7112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RAF1</a:t>
            </a:r>
            <a:endParaRPr lang="en-US" altLang="zh-CN">
              <a:sym typeface="+mn-ea"/>
            </a:endParaRPr>
          </a:p>
        </p:txBody>
      </p:sp>
      <p:sp>
        <p:nvSpPr>
          <p:cNvPr id="6" name="文本框 5"/>
          <p:cNvSpPr txBox="1"/>
          <p:nvPr>
            <p:custDataLst>
              <p:tags r:id="rId14"/>
            </p:custDataLst>
          </p:nvPr>
        </p:nvSpPr>
        <p:spPr>
          <a:xfrm>
            <a:off x="4929505" y="1898650"/>
            <a:ext cx="56261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TKT</a:t>
            </a:r>
            <a:endParaRPr lang="zh-CN" altLang="en-US"/>
          </a:p>
          <a:p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15"/>
            </p:custDataLst>
          </p:nvPr>
        </p:nvSpPr>
        <p:spPr>
          <a:xfrm>
            <a:off x="6811645" y="1793875"/>
            <a:ext cx="18218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	68kDa</a:t>
            </a:r>
            <a:endParaRPr lang="zh-CN" altLang="en-US"/>
          </a:p>
        </p:txBody>
      </p:sp>
      <p:sp>
        <p:nvSpPr>
          <p:cNvPr id="8" name="文本框 7"/>
          <p:cNvSpPr txBox="1"/>
          <p:nvPr>
            <p:custDataLst>
              <p:tags r:id="rId16"/>
            </p:custDataLst>
          </p:nvPr>
        </p:nvSpPr>
        <p:spPr>
          <a:xfrm>
            <a:off x="2637790" y="3794760"/>
            <a:ext cx="1941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	68kDa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606425" y="591820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F</a:t>
            </a:r>
            <a:endParaRPr lang="en-US" altLang="zh-CN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文本框 8"/>
          <p:cNvSpPr txBox="1"/>
          <p:nvPr/>
        </p:nvSpPr>
        <p:spPr>
          <a:xfrm>
            <a:off x="157480" y="81280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G</a:t>
            </a:r>
            <a:endParaRPr lang="en-US" altLang="zh-CN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10920" y="394335"/>
            <a:ext cx="1046480" cy="145796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1395" y="1925955"/>
            <a:ext cx="1041400" cy="158940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1395" y="3589020"/>
            <a:ext cx="1046480" cy="132969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1395" y="4992370"/>
            <a:ext cx="1056005" cy="1651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2380" y="305435"/>
            <a:ext cx="1144905" cy="132016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42380" y="1763395"/>
            <a:ext cx="1083310" cy="152527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42380" y="3426460"/>
            <a:ext cx="972820" cy="140335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42380" y="4903470"/>
            <a:ext cx="1043940" cy="1651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6409690" y="5756910"/>
            <a:ext cx="976630" cy="294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1066165" y="5845810"/>
            <a:ext cx="976630" cy="294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66675" y="577151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5330190" y="575691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521575" y="5756910"/>
            <a:ext cx="8959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2241550" y="5771515"/>
            <a:ext cx="8959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264795" y="4077970"/>
            <a:ext cx="659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A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2124710" y="4077970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7521575" y="4077970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5614670" y="4077970"/>
            <a:ext cx="659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A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62560" y="2466340"/>
            <a:ext cx="591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>
            <a:off x="2124710" y="2466340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7562850" y="2296160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5682615" y="2296160"/>
            <a:ext cx="591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141605" y="781685"/>
            <a:ext cx="85979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IB:Flag</a:t>
            </a:r>
            <a:endParaRPr lang="en-US" altLang="zh-CN">
              <a:sym typeface="+mn-ea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414645" y="725170"/>
            <a:ext cx="85979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IB:HA</a:t>
            </a:r>
            <a:endParaRPr lang="en-US" altLang="zh-CN">
              <a:sym typeface="+mn-ea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181225" y="781685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7555230" y="725170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42745" y="2070100"/>
            <a:ext cx="1320800" cy="124777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11835" y="2491105"/>
            <a:ext cx="643255" cy="2889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c-raf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203200" y="164465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I</a:t>
            </a:r>
            <a:endParaRPr lang="en-US" altLang="zh-CN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3065" y="3429000"/>
            <a:ext cx="1258570" cy="12954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0320" y="3893820"/>
            <a:ext cx="1642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c-Raf(Ser338)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9245" y="5109845"/>
            <a:ext cx="1342390" cy="125603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61340" y="560959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5440" y="473075"/>
            <a:ext cx="1348105" cy="136779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781685" y="1002030"/>
            <a:ext cx="573405" cy="4044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13500" y="3429000"/>
            <a:ext cx="1171575" cy="142367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11595" y="344170"/>
            <a:ext cx="1172845" cy="13208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11595" y="1866900"/>
            <a:ext cx="1172210" cy="145097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12865" y="5109845"/>
            <a:ext cx="1172210" cy="13462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838190" y="880110"/>
            <a:ext cx="573405" cy="4044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5641340" y="2382520"/>
            <a:ext cx="643255" cy="2889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c-raf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4692650" y="4020820"/>
            <a:ext cx="1642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c-Raf(Ser338)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5391150" y="560959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3108960" y="1038225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7701280" y="88011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3108960" y="2529205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7710805" y="243268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108960" y="3900170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7663180" y="405701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034030" y="5681345"/>
            <a:ext cx="8178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710805" y="5681345"/>
            <a:ext cx="8959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559425" y="2051685"/>
            <a:ext cx="1172845" cy="137668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9105" y="2186940"/>
            <a:ext cx="1426845" cy="13462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4495" y="3773805"/>
            <a:ext cx="1465580" cy="113220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483870" y="2675890"/>
            <a:ext cx="12452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RK1/2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363855" y="4155440"/>
            <a:ext cx="127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ERK1/2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59425" y="3615055"/>
            <a:ext cx="1127125" cy="131635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59425" y="532765"/>
            <a:ext cx="1031240" cy="132270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37870" y="1011555"/>
            <a:ext cx="802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74495" y="5105400"/>
            <a:ext cx="1386840" cy="137414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784860" y="577024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59425" y="5105400"/>
            <a:ext cx="1031240" cy="137096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74495" y="634365"/>
            <a:ext cx="1465580" cy="131191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03200" y="164465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J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669790" y="948690"/>
            <a:ext cx="802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4669790" y="2555875"/>
            <a:ext cx="12452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RK1/2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436110" y="4163060"/>
            <a:ext cx="127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ERK1/2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820285" y="577024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3274060" y="1011555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6732270" y="948690"/>
            <a:ext cx="13271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3228340" y="2783840"/>
            <a:ext cx="8324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6826250" y="2675890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228340" y="4163060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6856730" y="4163060"/>
            <a:ext cx="8261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228340" y="5770245"/>
            <a:ext cx="9518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6826250" y="5770245"/>
            <a:ext cx="8464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831840" y="678180"/>
            <a:ext cx="1257935" cy="133794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7480" y="154940"/>
            <a:ext cx="9055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D</a:t>
            </a:r>
            <a:endParaRPr lang="en-US" altLang="zh-CN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31840" y="2128520"/>
            <a:ext cx="1265555" cy="13722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0" y="2704465"/>
            <a:ext cx="12071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S62-Myc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157480" y="1193800"/>
            <a:ext cx="7905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1840" y="5171440"/>
            <a:ext cx="1242695" cy="145859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78765" y="5853430"/>
            <a:ext cx="8413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7135" y="2128520"/>
            <a:ext cx="1322070" cy="137223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7450" y="3613150"/>
            <a:ext cx="1341755" cy="145732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6035" y="4157980"/>
            <a:ext cx="11811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T58-Myc</a:t>
            </a:r>
            <a:endParaRPr lang="zh-CN" altLang="en-US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31840" y="3613150"/>
            <a:ext cx="1169035" cy="144589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68400" y="5182870"/>
            <a:ext cx="1386205" cy="1458595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978400" y="1103630"/>
            <a:ext cx="7905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561840" y="2757170"/>
            <a:ext cx="12071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S62-Myc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587875" y="4237355"/>
            <a:ext cx="11811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T58-Myc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4927600" y="5899150"/>
            <a:ext cx="8413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2759075" y="1103630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7202805" y="1103630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2744470" y="258635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7160260" y="263080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156450" y="423735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2682875" y="4157980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2682875" y="5899150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7158355" y="5856605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07135" y="732790"/>
            <a:ext cx="1346835" cy="1283335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15745" y="1041400"/>
            <a:ext cx="2766060" cy="129921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70510" y="21971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E </a:t>
            </a:r>
            <a:endParaRPr lang="en-US" altLang="zh-CN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5745" y="2594610"/>
            <a:ext cx="2728595" cy="125285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8095" y="2594610"/>
            <a:ext cx="2728595" cy="129984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1265" y="1041400"/>
            <a:ext cx="2765425" cy="121158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551815" y="14630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524510" y="3060700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5444490" y="14630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5430520" y="3060700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4281805" y="1463040"/>
            <a:ext cx="12344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9076690" y="14630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4345305" y="3140075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9177655" y="3140075"/>
            <a:ext cx="88519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5480050" y="21971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F </a:t>
            </a:r>
            <a:endParaRPr lang="en-US" altLang="zh-CN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" name="图片 1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61440" y="662940"/>
            <a:ext cx="2267585" cy="130746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0015" y="2473960"/>
            <a:ext cx="2239010" cy="129095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3805" y="662940"/>
            <a:ext cx="2167255" cy="130048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3805" y="2392680"/>
            <a:ext cx="2168525" cy="137223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70510" y="21971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G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5403850" y="16383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H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29260" y="10947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5403850" y="10947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429260" y="2935605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5338445" y="3001645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3694430" y="1094740"/>
            <a:ext cx="12344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8592185" y="1094740"/>
            <a:ext cx="12344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3775075" y="3001645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8576945" y="2935605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0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1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2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3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4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5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6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7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8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9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20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1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2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3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4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3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4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5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6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7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8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9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693D68C6E0D77543A531ECA1AF65242F" ma:contentTypeVersion="14" ma:contentTypeDescription="Ein neues Dokument erstellen." ma:contentTypeScope="" ma:versionID="84dd307a130a2036d49b71e74aa48da3">
  <xsd:schema xmlns:xsd="http://www.w3.org/2001/XMLSchema" xmlns:xs="http://www.w3.org/2001/XMLSchema" xmlns:p="http://schemas.microsoft.com/office/2006/metadata/properties" xmlns:ns2="4e9c1a30-ac29-4ee3-b6d2-64b56062261e" xmlns:ns3="571cf175-b3ea-4d86-8ad1-bfe8e99f11a0" targetNamespace="http://schemas.microsoft.com/office/2006/metadata/properties" ma:root="true" ma:fieldsID="3fdd19262e8dcae51b7e541ecf5d7d57" ns2:_="" ns3:_="">
    <xsd:import namespace="4e9c1a30-ac29-4ee3-b6d2-64b56062261e"/>
    <xsd:import namespace="571cf175-b3ea-4d86-8ad1-bfe8e99f11a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Loca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9c1a30-ac29-4ee3-b6d2-64b5606226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description="" ma:hidden="true" ma:indexed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7" nillable="true" ma:taxonomy="true" ma:internalName="lcf76f155ced4ddcb4097134ff3c332f" ma:taxonomyFieldName="MediaServiceImageTags" ma:displayName="Bildmarkierungen" ma:readOnly="false" ma:fieldId="{5cf76f15-5ced-4ddc-b409-7134ff3c332f}" ma:taxonomyMulti="true" ma:sspId="4fb58666-e629-4e5a-b780-b8dcc15b318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BillingMetadata" ma:index="21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1cf175-b3ea-4d86-8ad1-bfe8e99f11a0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ecf77b9a-b311-4a8a-8036-cc163133632b}" ma:internalName="TaxCatchAll" ma:showField="CatchAllData" ma:web="571cf175-b3ea-4d86-8ad1-bfe8e99f11a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71cf175-b3ea-4d86-8ad1-bfe8e99f11a0" xsi:nil="true"/>
    <lcf76f155ced4ddcb4097134ff3c332f xmlns="4e9c1a30-ac29-4ee3-b6d2-64b56062261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B534C6DB-A3CC-40CE-9632-6A37DE57F10C}"/>
</file>

<file path=customXml/itemProps2.xml><?xml version="1.0" encoding="utf-8"?>
<ds:datastoreItem xmlns:ds="http://schemas.openxmlformats.org/officeDocument/2006/customXml" ds:itemID="{320018F4-FA97-46C2-A644-AA44B5CB9490}"/>
</file>

<file path=customXml/itemProps3.xml><?xml version="1.0" encoding="utf-8"?>
<ds:datastoreItem xmlns:ds="http://schemas.openxmlformats.org/officeDocument/2006/customXml" ds:itemID="{3A2127DD-205A-41E5-8633-9E1D69C22477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4</Words>
  <Application>WPS 演示</Application>
  <PresentationFormat>宽屏</PresentationFormat>
  <Paragraphs>352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9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灼灼其华</cp:lastModifiedBy>
  <cp:revision>21</cp:revision>
  <dcterms:created xsi:type="dcterms:W3CDTF">2023-08-09T12:44:00Z</dcterms:created>
  <dcterms:modified xsi:type="dcterms:W3CDTF">2026-04-23T06:00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572673B2B18F43E6A3F69DE1FC4D4255_12</vt:lpwstr>
  </property>
  <property fmtid="{D5CDD505-2E9C-101B-9397-08002B2CF9AE}" pid="4" name="ContentTypeId">
    <vt:lpwstr>0x010100693D68C6E0D77543A531ECA1AF65242F</vt:lpwstr>
  </property>
</Properties>
</file>